
<file path=[Content_Types].xml><?xml version="1.0" encoding="utf-8"?>
<Types xmlns="http://schemas.openxmlformats.org/package/2006/content-types"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65" r:id="rId4"/>
    <p:sldId id="277" r:id="rId5"/>
    <p:sldId id="260" r:id="rId6"/>
    <p:sldId id="261" r:id="rId7"/>
    <p:sldId id="262" r:id="rId8"/>
    <p:sldId id="263" r:id="rId9"/>
  </p:sldIdLst>
  <p:sldSz cx="6858000" cy="9906000" type="A4"/>
  <p:notesSz cx="68580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6" d="100"/>
          <a:sy n="56" d="100"/>
        </p:scale>
        <p:origin x="2621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773AFA-1B09-4A36-828B-5069648D72C7}" type="datetimeFigureOut">
              <a:rPr lang="en-IN" smtClean="0"/>
              <a:t>06-04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238250"/>
            <a:ext cx="2314575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767263"/>
            <a:ext cx="5486400" cy="39004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91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4091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0D302D-8F42-489E-8E2F-BC76742C16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921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DD0FB1-AC09-4136-A997-BA0705B58CEC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096871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14350" y="3070860"/>
            <a:ext cx="5829300" cy="208025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28700" y="5547360"/>
            <a:ext cx="4800600" cy="2476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42900" y="2278380"/>
            <a:ext cx="298323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531870" y="2278380"/>
            <a:ext cx="298323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6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6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6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42900" y="396240"/>
            <a:ext cx="6172200" cy="1584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42900" y="2278380"/>
            <a:ext cx="617220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331720" y="9212580"/>
            <a:ext cx="219456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42900" y="9212580"/>
            <a:ext cx="157734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937760" y="9212580"/>
            <a:ext cx="157734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3.jpg"/><Relationship Id="rId3" Type="http://schemas.openxmlformats.org/officeDocument/2006/relationships/image" Target="../media/image23.jpg"/><Relationship Id="rId7" Type="http://schemas.openxmlformats.org/officeDocument/2006/relationships/image" Target="../media/image27.jpg"/><Relationship Id="rId12" Type="http://schemas.openxmlformats.org/officeDocument/2006/relationships/image" Target="../media/image32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26.jpg"/><Relationship Id="rId11" Type="http://schemas.openxmlformats.org/officeDocument/2006/relationships/image" Target="../media/image31.jpg"/><Relationship Id="rId5" Type="http://schemas.openxmlformats.org/officeDocument/2006/relationships/image" Target="../media/image25.jpg"/><Relationship Id="rId15" Type="http://schemas.openxmlformats.org/officeDocument/2006/relationships/image" Target="../media/image35.png"/><Relationship Id="rId10" Type="http://schemas.openxmlformats.org/officeDocument/2006/relationships/image" Target="../media/image30.jpg"/><Relationship Id="rId4" Type="http://schemas.openxmlformats.org/officeDocument/2006/relationships/image" Target="../media/image24.jpg"/><Relationship Id="rId9" Type="http://schemas.openxmlformats.org/officeDocument/2006/relationships/image" Target="../media/image29.jpg"/><Relationship Id="rId14" Type="http://schemas.openxmlformats.org/officeDocument/2006/relationships/image" Target="../media/image34.jp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517170" y="3106034"/>
            <a:ext cx="5800776" cy="2977116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72592" y="328625"/>
            <a:ext cx="946150" cy="3003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dirty="0">
                <a:latin typeface="Calibri"/>
                <a:cs typeface="Calibri"/>
              </a:rPr>
              <a:t>Figu</a:t>
            </a:r>
            <a:r>
              <a:rPr sz="1800" b="1" spc="-30" dirty="0">
                <a:latin typeface="Calibri"/>
                <a:cs typeface="Calibri"/>
              </a:rPr>
              <a:t>r</a:t>
            </a:r>
            <a:r>
              <a:rPr sz="1800" b="1" spc="-5" dirty="0">
                <a:latin typeface="Calibri"/>
                <a:cs typeface="Calibri"/>
              </a:rPr>
              <a:t>e</a:t>
            </a:r>
            <a:r>
              <a:rPr sz="1800" b="1" dirty="0">
                <a:latin typeface="Calibri"/>
                <a:cs typeface="Calibri"/>
              </a:rPr>
              <a:t>.</a:t>
            </a:r>
            <a:r>
              <a:rPr sz="1800" b="1" spc="-25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S1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246841" y="1491007"/>
            <a:ext cx="4470614" cy="2026113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899208" y="1298731"/>
            <a:ext cx="784497" cy="2444451"/>
          </a:xfrm>
          <a:prstGeom prst="rect">
            <a:avLst/>
          </a:prstGeom>
        </p:spPr>
      </p:pic>
      <p:sp>
        <p:nvSpPr>
          <p:cNvPr id="4" name="object 4"/>
          <p:cNvSpPr txBox="1"/>
          <p:nvPr/>
        </p:nvSpPr>
        <p:spPr>
          <a:xfrm>
            <a:off x="272592" y="1374775"/>
            <a:ext cx="21907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10" dirty="0">
                <a:latin typeface="Calibri"/>
                <a:cs typeface="Calibri"/>
              </a:rPr>
              <a:t>A.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272592" y="328625"/>
            <a:ext cx="946785" cy="3003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Figure.</a:t>
            </a:r>
            <a:r>
              <a:rPr sz="1800" b="1" spc="-9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S2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2542794" y="1377137"/>
            <a:ext cx="208915" cy="3003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B.</a:t>
            </a:r>
            <a:endParaRPr sz="1800">
              <a:latin typeface="Calibri"/>
              <a:cs typeface="Calibri"/>
            </a:endParaRPr>
          </a:p>
        </p:txBody>
      </p:sp>
      <p:pic>
        <p:nvPicPr>
          <p:cNvPr id="7" name="object 7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245363" y="4819403"/>
            <a:ext cx="2831508" cy="2669532"/>
          </a:xfrm>
          <a:prstGeom prst="rect">
            <a:avLst/>
          </a:prstGeom>
        </p:spPr>
      </p:pic>
      <p:pic>
        <p:nvPicPr>
          <p:cNvPr id="8" name="object 8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3732028" y="4828493"/>
            <a:ext cx="2690676" cy="2469942"/>
          </a:xfrm>
          <a:prstGeom prst="rect">
            <a:avLst/>
          </a:prstGeom>
        </p:spPr>
      </p:pic>
      <p:sp>
        <p:nvSpPr>
          <p:cNvPr id="9" name="object 9"/>
          <p:cNvSpPr txBox="1"/>
          <p:nvPr/>
        </p:nvSpPr>
        <p:spPr>
          <a:xfrm>
            <a:off x="272592" y="4486147"/>
            <a:ext cx="205104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C.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3419983" y="4602226"/>
            <a:ext cx="21399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40" dirty="0">
                <a:latin typeface="Calibri"/>
                <a:cs typeface="Calibri"/>
              </a:rPr>
              <a:t>D.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275260D-DCCE-DEC4-5A3E-09387E8603F8}"/>
              </a:ext>
            </a:extLst>
          </p:cNvPr>
          <p:cNvSpPr txBox="1"/>
          <p:nvPr/>
        </p:nvSpPr>
        <p:spPr>
          <a:xfrm>
            <a:off x="6401929" y="4828646"/>
            <a:ext cx="548821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3A86F22-5D61-A39F-46AF-AA72C79DF3E1}"/>
              </a:ext>
            </a:extLst>
          </p:cNvPr>
          <p:cNvSpPr txBox="1"/>
          <p:nvPr/>
        </p:nvSpPr>
        <p:spPr>
          <a:xfrm>
            <a:off x="2106162" y="501299"/>
            <a:ext cx="28109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Dysregulated genes after OE of USP37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7F8DA7E-9B4E-4F8E-B331-73A7185DB8A9}"/>
              </a:ext>
            </a:extLst>
          </p:cNvPr>
          <p:cNvSpPr/>
          <p:nvPr/>
        </p:nvSpPr>
        <p:spPr>
          <a:xfrm>
            <a:off x="193534" y="851883"/>
            <a:ext cx="6602838" cy="41557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2D81F4D2-6A8C-476C-990E-F19654F46E7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" b="16079"/>
          <a:stretch/>
        </p:blipFill>
        <p:spPr>
          <a:xfrm>
            <a:off x="6029217" y="4703826"/>
            <a:ext cx="664369" cy="133331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7A926AD-8D8F-464A-BFD0-F3197BB3CACA}"/>
              </a:ext>
            </a:extLst>
          </p:cNvPr>
          <p:cNvSpPr txBox="1"/>
          <p:nvPr/>
        </p:nvSpPr>
        <p:spPr>
          <a:xfrm>
            <a:off x="5772053" y="4838340"/>
            <a:ext cx="548821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-9</a:t>
            </a:r>
          </a:p>
        </p:txBody>
      </p:sp>
      <p:graphicFrame>
        <p:nvGraphicFramePr>
          <p:cNvPr id="32" name="Table 31">
            <a:extLst>
              <a:ext uri="{FF2B5EF4-FFF2-40B4-BE49-F238E27FC236}">
                <a16:creationId xmlns:a16="http://schemas.microsoft.com/office/drawing/2014/main" id="{84068A9D-32D0-43A8-9324-3F2023367CA0}"/>
              </a:ext>
            </a:extLst>
          </p:cNvPr>
          <p:cNvGraphicFramePr>
            <a:graphicFrameLocks noGrp="1"/>
          </p:cNvGraphicFramePr>
          <p:nvPr/>
        </p:nvGraphicFramePr>
        <p:xfrm>
          <a:off x="178594" y="1097928"/>
          <a:ext cx="6500812" cy="3535473"/>
        </p:xfrm>
        <a:graphic>
          <a:graphicData uri="http://schemas.openxmlformats.org/drawingml/2006/table">
            <a:tbl>
              <a:tblPr/>
              <a:tblGrid>
                <a:gridCol w="282644">
                  <a:extLst>
                    <a:ext uri="{9D8B030D-6E8A-4147-A177-3AD203B41FA5}">
                      <a16:colId xmlns:a16="http://schemas.microsoft.com/office/drawing/2014/main" val="3804369563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626044752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839158335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789646773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3262686100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453480746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80051322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3579508112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298701090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181032689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074245565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47767032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438700390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391303335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670765606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529619364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098122248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548561646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4120342944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1474657574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859639845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2347260516"/>
                    </a:ext>
                  </a:extLst>
                </a:gridCol>
                <a:gridCol w="282644">
                  <a:extLst>
                    <a:ext uri="{9D8B030D-6E8A-4147-A177-3AD203B41FA5}">
                      <a16:colId xmlns:a16="http://schemas.microsoft.com/office/drawing/2014/main" val="556599997"/>
                    </a:ext>
                  </a:extLst>
                </a:gridCol>
              </a:tblGrid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BLIM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928654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E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IC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D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CGBP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E9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QC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S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4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E6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TGER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B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C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6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C47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5061828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2525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E4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DH1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I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1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GF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8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9A1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TGAM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TN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6CD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TPRR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E9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C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FD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7467263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4477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EA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OX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7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9E2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STN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GF2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CD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UN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DG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D9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EA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YK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3905498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4801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X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N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CF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NI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BTBD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IOC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S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D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UCLG2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9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4110497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4987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GPTL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NM3-DT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CD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OXD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D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CNMB2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F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MO1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SL11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VOPL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4706740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5077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1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K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T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A8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UT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7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CNQ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F4G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C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SSF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CB8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YNC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3840936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5392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E9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TXR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17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6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YB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DB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IAA121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MP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CAN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YTL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3255223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5821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D0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C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A63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6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LNT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IF21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E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O1G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4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GS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C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YTL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5010556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6252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OBEC3H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5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2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6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S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F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IF3C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T1L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GS9BP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0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AS1R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1408991"/>
                  </a:ext>
                </a:extLst>
              </a:tr>
              <a:tr h="92294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9108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CE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OL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09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PA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8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9D2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S6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F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DC7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F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AV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HOXF1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5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DC99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F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C27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7309492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1448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AB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HGAP2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F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PNE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A63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S6-DT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DC7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5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F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CF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IPK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DB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EX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9D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0323227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2435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2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2CB9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HGAP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CC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RYBG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B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B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L3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NASEL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EX2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1137957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9080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E9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HGDI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RYBG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BP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RG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AB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CAB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AC4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LP0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HAP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7080521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0910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E4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L17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19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SPG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NT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MO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K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S6K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2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CA8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IAF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84868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3043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EC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L4C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TH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E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DP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E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REMEN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S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D3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RA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LR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5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A12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6285790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5678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D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NT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6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XCL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8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GT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RT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FATC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1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A5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100A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D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255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0659585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6785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7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SI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C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YB5R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B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JB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AMC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0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ME2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E2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1PR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5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3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45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C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9124288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7796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A4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SB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A8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YP19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A8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LDN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APTM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PY4R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1PR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9B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9D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4621918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34213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SNS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4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E7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YP3A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C8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LIPR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BH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C7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SF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9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C17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AMD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O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4165493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53481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CE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P2A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CST1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E9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LTPD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F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DH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C8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DT4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DF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ARDH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0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AIP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2345086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87501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ED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P8B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DO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E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OLGA8IP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8.2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971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7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E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PR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F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CIN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AIP8L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6128349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87588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E1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3GNT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8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NND2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OLGA8R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DB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23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EC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YNRIN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1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CN4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RSF1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AA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8723429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0192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AIAP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S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5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3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9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52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C7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LENOP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9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SF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D39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490265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2123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D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CO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1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GK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NM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DB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57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AS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C8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MA3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AF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9043973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05942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D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MP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CB8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HRS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E8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R137C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AB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63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9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LFML2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MA3G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D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ANK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4C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5042621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16025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D0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OLA2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E6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HRS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8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9A1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R8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A3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66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ED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R2B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4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CA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PT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IB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EC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357182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20498.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D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QTNF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AC4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KK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RC5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9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F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TX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H2D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SKS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E2C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6883791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31235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D0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2orf27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0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NAH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E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RI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92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9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2RX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H3TC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SPAN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DB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609144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38150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F0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5AR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C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OCK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AB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08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A4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MR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HIS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SPAN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9568785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44831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E4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USP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1F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5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F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1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CB8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CK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E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NHCAF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UBB2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5702950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245100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9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BLES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USP1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APLN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3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CB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CSK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A3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16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UBB4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FB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4689480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245100.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CF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LHM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D8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USP2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ST1H1E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E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4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DZD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9A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UBE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F1E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7830564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SL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1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MT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D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CM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ST1H2AC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53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DZK1I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8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9B1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A1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C8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2AF1L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19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2370718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TBL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4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C7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PN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CM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C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ST1H2APS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A8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7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A8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ECAM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5A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BA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3952017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VRL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TSPER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FB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EP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5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C67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ST1H2BO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E8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84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GBD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F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6A1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E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C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AB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8652192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AMTS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F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TSPER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E0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FEM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B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ST3H2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D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8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HET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6A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ED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CN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7191252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CY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D4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BS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F0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FNA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VEP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PG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8A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IP5KL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E8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7A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E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LB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FD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278648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M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6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E5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BSL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8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C7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ID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F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PG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A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MO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ITX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C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7A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D3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NC5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ED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0985312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HNAK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DC9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ML2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CF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SPA1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G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KD1L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0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MOX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LDLR-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E1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3952905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KN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2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7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OMES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TR3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RC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A2G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4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NHG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ED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FA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FD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2327030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021807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2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C48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8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F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PHB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1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TRA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C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RC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AC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F0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NHG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ED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KSCAN2-DT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9D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8678055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031123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AC4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H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7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AB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TNK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YAL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RN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AT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NHG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F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48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6009071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078612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D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EACAM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B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VA1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3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C88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DO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AC4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UZ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B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6A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OCS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0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58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F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565904"/>
                  </a:ext>
                </a:extLst>
              </a:tr>
              <a:tr h="80908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109615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EA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EACAMP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2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C98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C3L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F1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FI4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Y6D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DFB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EKHS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DE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OX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5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59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E8D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7023668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132656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9CE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GN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13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AC4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GFL1P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YPD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NPLA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4CC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ATA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3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A32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86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1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4921327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138976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E4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AC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E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BP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1RN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D3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F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PP1R3G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DC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EG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8225034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355483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8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AA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D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D9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24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0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CD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E6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P3K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E3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AT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F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ICE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66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357060.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D6A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ST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2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61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7R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9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3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PK8IP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G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A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OCD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6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C5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009785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590004.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1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CB8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IIT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F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27B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47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CA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HBA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09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RCHF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01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A7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G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D4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TBN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CF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29418"/>
                  </a:ext>
                </a:extLst>
              </a:tr>
              <a:tr h="6754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592164.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E2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CN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4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E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83F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DB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HBE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48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DF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RCO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5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E4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PH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6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C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RGAP3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2</a:t>
                      </a: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E0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N" sz="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210" marR="2210" marT="22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1386301"/>
                  </a:ext>
                </a:extLst>
              </a:tr>
            </a:tbl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C1DC91D5-B4B4-4FB1-8964-6A3798EEEE10}"/>
              </a:ext>
            </a:extLst>
          </p:cNvPr>
          <p:cNvSpPr txBox="1"/>
          <p:nvPr/>
        </p:nvSpPr>
        <p:spPr>
          <a:xfrm rot="19831902">
            <a:off x="191920" y="857061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4EBB308-22C0-438C-A98B-BA7650CA593F}"/>
              </a:ext>
            </a:extLst>
          </p:cNvPr>
          <p:cNvSpPr txBox="1"/>
          <p:nvPr/>
        </p:nvSpPr>
        <p:spPr>
          <a:xfrm rot="19831902">
            <a:off x="1015331" y="857061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BC310B6-85D3-49FB-9600-5738DBE249B5}"/>
              </a:ext>
            </a:extLst>
          </p:cNvPr>
          <p:cNvSpPr txBox="1"/>
          <p:nvPr/>
        </p:nvSpPr>
        <p:spPr>
          <a:xfrm rot="19831902">
            <a:off x="1875207" y="857061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AA1B8E0-1FDA-4E2F-973C-65865CC0D1E5}"/>
              </a:ext>
            </a:extLst>
          </p:cNvPr>
          <p:cNvSpPr txBox="1"/>
          <p:nvPr/>
        </p:nvSpPr>
        <p:spPr>
          <a:xfrm rot="19831902">
            <a:off x="2734850" y="863712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53FED8B-1D79-461C-94C8-55879CC6C153}"/>
              </a:ext>
            </a:extLst>
          </p:cNvPr>
          <p:cNvSpPr txBox="1"/>
          <p:nvPr/>
        </p:nvSpPr>
        <p:spPr>
          <a:xfrm rot="19831902">
            <a:off x="3564680" y="857062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D86752C-CA0F-4683-A097-6F61848149A5}"/>
              </a:ext>
            </a:extLst>
          </p:cNvPr>
          <p:cNvSpPr txBox="1"/>
          <p:nvPr/>
        </p:nvSpPr>
        <p:spPr>
          <a:xfrm rot="19831902">
            <a:off x="4418137" y="843998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ACBB940-08E0-4832-A6F9-4F94A56D0B25}"/>
              </a:ext>
            </a:extLst>
          </p:cNvPr>
          <p:cNvSpPr txBox="1"/>
          <p:nvPr/>
        </p:nvSpPr>
        <p:spPr>
          <a:xfrm rot="19831902">
            <a:off x="5278012" y="843999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9A5EFB0-B127-4190-9E43-2BE2FF796AD0}"/>
              </a:ext>
            </a:extLst>
          </p:cNvPr>
          <p:cNvSpPr txBox="1"/>
          <p:nvPr/>
        </p:nvSpPr>
        <p:spPr>
          <a:xfrm rot="19831902">
            <a:off x="6101423" y="857060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3F00940-1D68-4049-9AB5-63A5DB1EAC03}"/>
              </a:ext>
            </a:extLst>
          </p:cNvPr>
          <p:cNvSpPr/>
          <p:nvPr/>
        </p:nvSpPr>
        <p:spPr>
          <a:xfrm>
            <a:off x="193534" y="5622680"/>
            <a:ext cx="6587898" cy="40625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CED59F97-79D6-4114-9BB1-E177D525417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10"/>
          <a:stretch/>
        </p:blipFill>
        <p:spPr>
          <a:xfrm>
            <a:off x="5967075" y="9315675"/>
            <a:ext cx="664369" cy="138410"/>
          </a:xfrm>
          <a:prstGeom prst="rect">
            <a:avLst/>
          </a:prstGeom>
        </p:spPr>
      </p:pic>
      <p:graphicFrame>
        <p:nvGraphicFramePr>
          <p:cNvPr id="56" name="Table 55">
            <a:extLst>
              <a:ext uri="{FF2B5EF4-FFF2-40B4-BE49-F238E27FC236}">
                <a16:creationId xmlns:a16="http://schemas.microsoft.com/office/drawing/2014/main" id="{11338F0B-9A4B-44E2-99FE-94D257475965}"/>
              </a:ext>
            </a:extLst>
          </p:cNvPr>
          <p:cNvGraphicFramePr>
            <a:graphicFrameLocks noGrp="1"/>
          </p:cNvGraphicFramePr>
          <p:nvPr/>
        </p:nvGraphicFramePr>
        <p:xfrm>
          <a:off x="316394" y="5922981"/>
          <a:ext cx="6269354" cy="3352840"/>
        </p:xfrm>
        <a:graphic>
          <a:graphicData uri="http://schemas.openxmlformats.org/drawingml/2006/table">
            <a:tbl>
              <a:tblPr/>
              <a:tblGrid>
                <a:gridCol w="241129">
                  <a:extLst>
                    <a:ext uri="{9D8B030D-6E8A-4147-A177-3AD203B41FA5}">
                      <a16:colId xmlns:a16="http://schemas.microsoft.com/office/drawing/2014/main" val="2476337391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1212777539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3841215468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2728600836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112595739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3726906886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659793179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2110569261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2179853291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866616309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726938763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43036966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600229079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825550493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850252134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2874587648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3333336831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1507561585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3468296060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1912523272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3424506175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826950794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2389213420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3064138195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2930883215"/>
                    </a:ext>
                  </a:extLst>
                </a:gridCol>
                <a:gridCol w="241129">
                  <a:extLst>
                    <a:ext uri="{9D8B030D-6E8A-4147-A177-3AD203B41FA5}">
                      <a16:colId xmlns:a16="http://schemas.microsoft.com/office/drawing/2014/main" val="145131811"/>
                    </a:ext>
                  </a:extLst>
                </a:gridCol>
              </a:tblGrid>
              <a:tr h="97376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2M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4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162377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BE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M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KDC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7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PIPA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2B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HOXF1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AC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6C8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6609614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BCC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354719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DC1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0B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NC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6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MGA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88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RE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1DC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NF144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A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C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AB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174715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BCC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4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355512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L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CCC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NO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8CA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MGB1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8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194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89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TN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NF15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8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V2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CC0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7096262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2525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358777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96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L2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6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496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NTPD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7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DB5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OXA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7D5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9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CCD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TSR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NF16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VOP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8A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749418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4801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365203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H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CC0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PGN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RK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9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7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5A5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DT4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9B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L12P1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8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BXA2R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0DC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0788926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4987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DC1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590560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K5RAP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PS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SPA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D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13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PR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L13AP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CTN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5DF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927994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6001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9B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590644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KN2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RE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TR7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4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1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YNRIN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EC2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RM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HAP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FA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3054474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8429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592164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96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DKN2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4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RN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TRA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13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LFM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S10P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HORLN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8890829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08982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1D0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G1L13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EBP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RRFI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D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D3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26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LFML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188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SPO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INAGL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6909017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1815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6D4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PI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4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GN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BCC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TNK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ER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C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3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2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PN1SW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D0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UNX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JP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310176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2435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76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X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7C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AC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TNPP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A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FIT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14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BCC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R51B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C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1PR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151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37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997474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7002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OT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087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RM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188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TV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GSF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P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SBPL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1PR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D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15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96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252508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17104.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PD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RND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BCC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TV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2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MO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5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TO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CCD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AMD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2C5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EM45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AB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350711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5678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GPTL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ST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FD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MO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2RY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8D5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CN1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MOD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9877980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26336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6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F86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K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3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CNK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A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10D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ECE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1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4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XL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4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G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0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CN4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1682571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34213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9B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KR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2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DN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868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24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8C9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G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8D5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LM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1DC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DR16C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RSF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BBF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499441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53481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XA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D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GN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2A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29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RC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1DC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SK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LENO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0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A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RSF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9B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5845872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73611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C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087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N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67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5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RRC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EDA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CDH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MA3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SF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2D1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8683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87501.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X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11A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E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24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8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7R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D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UZP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D0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CK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MA6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D3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NT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7D5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7252750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89983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0B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000845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14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D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72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HBE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D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F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CCC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GF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4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RPINE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B1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6C8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4812837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2807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001372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4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1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FD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86B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MT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5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FF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HLD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RPINE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GARAM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2DD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999628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3001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2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001453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3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6C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86B3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PP5D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A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L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IK3CD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4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RPINI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PB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3078047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3802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6C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001469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9A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5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CGB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PP5J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7D5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AS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5A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IP5K1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SN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IB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5439836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6677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002761.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8.4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07B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PA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4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4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CMR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SL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0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DK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IP5KL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3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H3B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8C9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SHZ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AD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7466191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098487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E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P002884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PLANE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GF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QGAP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0D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OX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5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1B8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K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HC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SPAN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9A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915673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03706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AP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REB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GF2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171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SG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FAP3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KD1P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D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HF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8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194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TC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A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9503195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09347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7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RYBG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GFR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SLR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698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FSD2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5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KDC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CF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12A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A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TYH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0DC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4158604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16021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HGAP2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ST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CB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LRT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5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F9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TGA2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8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R368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AC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1A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798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UBB4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2D1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255301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24798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L17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CCC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XCL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9A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N3K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0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ECE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TGA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R503HG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0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LK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2A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8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2AF1L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4D3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9427699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26755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SNS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XCL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4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OX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TGB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LXIP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NPL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0B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2A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LB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4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1889016"/>
                  </a:ext>
                </a:extLst>
              </a:tr>
              <a:tr h="53786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26773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78D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OH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7D5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YB5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96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ST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9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C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AG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MP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FD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PDPF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2C5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5A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5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NC13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4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725628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38028.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5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P1A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YP2R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UT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BTBD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OGAT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6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496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AG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5A3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NC5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6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2B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3420115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38150.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P8B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5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ND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5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DD45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CNQ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8D6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BPC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2D1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G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9A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SH1C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EC2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3916340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138932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XIN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678D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DIT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3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GE12E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HK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1DC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EOV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9A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SS2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A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2A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9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D0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ASH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AD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9526930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233968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4GALNT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4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7C9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DX5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DF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9A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IAA1549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96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H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APL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.9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982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35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EGF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5212658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245100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D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AIAP2-DT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EDA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FB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8D5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DP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IF21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LK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ECE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C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F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48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GF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4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1A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187818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245100.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CAR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A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NND2D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IPC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4D3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DC7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5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LK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ORS1C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0B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4A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LDLR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2510034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ADS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0D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DKRB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BCB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PDC1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0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OLGA6L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L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YO7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SPH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5A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9D6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CCHC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5DF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968743"/>
                  </a:ext>
                </a:extLst>
              </a:tr>
              <a:tr h="52692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A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EST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B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S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EC2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OLGA8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LHL3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7B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CCR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3D1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XYL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0DB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6A1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G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2DD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1048411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GRL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8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IRC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HRS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3D3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L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DC1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REMEN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3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DUFA4L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6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2C5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YGM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9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CC0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7A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529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0D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336861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IRF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OLA2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GDH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8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R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9B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RT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1C4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AT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B7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9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9A3-AS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585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1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D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0288104"/>
                  </a:ext>
                </a:extLst>
              </a:tr>
              <a:tr h="52692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M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9A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TN3A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D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NAH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5E5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R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0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RT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8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CAB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8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PGEF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8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LCO2A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D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NF8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5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6495415"/>
                  </a:ext>
                </a:extLst>
              </a:tr>
              <a:tr h="52692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AP7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4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QL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5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5C7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USP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PT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7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0C3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ARGE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9CA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CTIN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2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ARRES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MG1P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4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58389688"/>
                  </a:ext>
                </a:extLst>
              </a:tr>
              <a:tr h="52692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R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EA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6orf13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AB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USP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4A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RK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ARP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ES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3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3BA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BP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5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3B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NHG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2291960"/>
                  </a:ext>
                </a:extLst>
              </a:tr>
              <a:tr h="52692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JUB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1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BP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4.8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BB3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CM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STA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3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ACB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ETM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9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959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FATC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6D4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BPJ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RED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4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80687058"/>
                  </a:ext>
                </a:extLst>
              </a:tr>
              <a:tr h="52692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KN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CNA1A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8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CM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8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82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YG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CD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F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KD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1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DCD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CAN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5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RY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3A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1803233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049796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CNB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1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3DE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GFL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APLN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4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BD8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23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2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LRP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9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C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F0225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SB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8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FC3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1488326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096828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AB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LY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6D4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ID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BA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ACB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248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00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MRAL2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GS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698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TB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3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DD9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2676852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109615.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0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C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IF4HP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9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C6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HAT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5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494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57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6.5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698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UM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69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7D4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GS9BP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3.2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BCB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RGAP3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8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3D2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2165719"/>
                  </a:ext>
                </a:extLst>
              </a:tr>
              <a:tr h="68703"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160254.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24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BSL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6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5D5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LOVL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2.7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D3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ST1H2BO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3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NC0066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PAS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1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HEBL1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48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RPX2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36</a:t>
                      </a: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IN" sz="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416" marR="2416" marT="24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49230833"/>
                  </a:ext>
                </a:extLst>
              </a:tr>
            </a:tbl>
          </a:graphicData>
        </a:graphic>
      </p:graphicFrame>
      <p:sp>
        <p:nvSpPr>
          <p:cNvPr id="57" name="TextBox 56">
            <a:extLst>
              <a:ext uri="{FF2B5EF4-FFF2-40B4-BE49-F238E27FC236}">
                <a16:creationId xmlns:a16="http://schemas.microsoft.com/office/drawing/2014/main" id="{18C296DF-33D3-4BC0-9DAA-F1722FA6FD53}"/>
              </a:ext>
            </a:extLst>
          </p:cNvPr>
          <p:cNvSpPr txBox="1"/>
          <p:nvPr/>
        </p:nvSpPr>
        <p:spPr>
          <a:xfrm>
            <a:off x="5692664" y="9414334"/>
            <a:ext cx="548821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-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89603AC-D398-478C-9008-7074BB1361AB}"/>
              </a:ext>
            </a:extLst>
          </p:cNvPr>
          <p:cNvSpPr txBox="1"/>
          <p:nvPr/>
        </p:nvSpPr>
        <p:spPr>
          <a:xfrm>
            <a:off x="6344194" y="9417048"/>
            <a:ext cx="548821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42B3702-06EB-4A19-80CF-26F73EA60873}"/>
              </a:ext>
            </a:extLst>
          </p:cNvPr>
          <p:cNvSpPr txBox="1"/>
          <p:nvPr/>
        </p:nvSpPr>
        <p:spPr>
          <a:xfrm rot="19831902">
            <a:off x="313491" y="5689323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B3662A4-FB6F-4409-A415-D6062AA30969}"/>
              </a:ext>
            </a:extLst>
          </p:cNvPr>
          <p:cNvSpPr txBox="1"/>
          <p:nvPr/>
        </p:nvSpPr>
        <p:spPr>
          <a:xfrm rot="19831902">
            <a:off x="1014269" y="5689325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56E8884-783E-4357-99E2-1B3CFB99531E}"/>
              </a:ext>
            </a:extLst>
          </p:cNvPr>
          <p:cNvSpPr txBox="1"/>
          <p:nvPr/>
        </p:nvSpPr>
        <p:spPr>
          <a:xfrm rot="19831902">
            <a:off x="1742617" y="5689324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A8B2704-E62C-4F3A-8A9B-D787C9F1E300}"/>
              </a:ext>
            </a:extLst>
          </p:cNvPr>
          <p:cNvSpPr txBox="1"/>
          <p:nvPr/>
        </p:nvSpPr>
        <p:spPr>
          <a:xfrm rot="19831902">
            <a:off x="2467466" y="5698283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5502377-81A5-4BB5-8EB1-99FD6B09C3A0}"/>
              </a:ext>
            </a:extLst>
          </p:cNvPr>
          <p:cNvSpPr txBox="1"/>
          <p:nvPr/>
        </p:nvSpPr>
        <p:spPr>
          <a:xfrm rot="19831902">
            <a:off x="3181989" y="5689325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B6676E8-68C6-4101-978D-DCABDED8A0AB}"/>
              </a:ext>
            </a:extLst>
          </p:cNvPr>
          <p:cNvSpPr txBox="1"/>
          <p:nvPr/>
        </p:nvSpPr>
        <p:spPr>
          <a:xfrm rot="19831902">
            <a:off x="3906837" y="5689323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441785D-AC06-40BC-9471-B6946805FDB7}"/>
              </a:ext>
            </a:extLst>
          </p:cNvPr>
          <p:cNvSpPr txBox="1"/>
          <p:nvPr/>
        </p:nvSpPr>
        <p:spPr>
          <a:xfrm rot="19831902">
            <a:off x="4648607" y="5689323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91FBB61-480B-4B99-81CA-5AFAF8DEA0C2}"/>
              </a:ext>
            </a:extLst>
          </p:cNvPr>
          <p:cNvSpPr txBox="1"/>
          <p:nvPr/>
        </p:nvSpPr>
        <p:spPr>
          <a:xfrm rot="19831902">
            <a:off x="5349619" y="5678766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705E5EA-D933-4607-B4A2-0A71C0C2E171}"/>
              </a:ext>
            </a:extLst>
          </p:cNvPr>
          <p:cNvSpPr txBox="1"/>
          <p:nvPr/>
        </p:nvSpPr>
        <p:spPr>
          <a:xfrm rot="19831902">
            <a:off x="6077966" y="5669568"/>
            <a:ext cx="368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4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D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A06EF68-7209-416C-A536-34951D9B3243}"/>
              </a:ext>
            </a:extLst>
          </p:cNvPr>
          <p:cNvSpPr txBox="1"/>
          <p:nvPr/>
        </p:nvSpPr>
        <p:spPr>
          <a:xfrm>
            <a:off x="2126256" y="5221899"/>
            <a:ext cx="281090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Dysregulated genes after KO of USP37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99C502E-0A6E-48DC-9D3B-AF265B6E8D67}"/>
              </a:ext>
            </a:extLst>
          </p:cNvPr>
          <p:cNvSpPr txBox="1"/>
          <p:nvPr/>
        </p:nvSpPr>
        <p:spPr>
          <a:xfrm>
            <a:off x="104236" y="469807"/>
            <a:ext cx="491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.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A5F78F1-EDDA-41AD-9E4B-6E71A6EA302D}"/>
              </a:ext>
            </a:extLst>
          </p:cNvPr>
          <p:cNvSpPr txBox="1"/>
          <p:nvPr/>
        </p:nvSpPr>
        <p:spPr>
          <a:xfrm>
            <a:off x="81951" y="5248868"/>
            <a:ext cx="491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FBC091D-542D-427C-97E0-B12D27AC7D14}"/>
              </a:ext>
            </a:extLst>
          </p:cNvPr>
          <p:cNvSpPr txBox="1"/>
          <p:nvPr/>
        </p:nvSpPr>
        <p:spPr>
          <a:xfrm>
            <a:off x="332956" y="162046"/>
            <a:ext cx="176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.S3</a:t>
            </a:r>
          </a:p>
        </p:txBody>
      </p:sp>
    </p:spTree>
    <p:extLst>
      <p:ext uri="{BB962C8B-B14F-4D97-AF65-F5344CB8AC3E}">
        <p14:creationId xmlns:p14="http://schemas.microsoft.com/office/powerpoint/2010/main" val="8165705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483727E-A466-48AE-BD70-4B3884D6EE7E}"/>
              </a:ext>
            </a:extLst>
          </p:cNvPr>
          <p:cNvGrpSpPr/>
          <p:nvPr/>
        </p:nvGrpSpPr>
        <p:grpSpPr>
          <a:xfrm>
            <a:off x="23630" y="1048867"/>
            <a:ext cx="6645612" cy="3890309"/>
            <a:chOff x="75505" y="2991504"/>
            <a:chExt cx="6645612" cy="3890309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61EBB961-C71F-4940-97D5-520FBC8A4A09}"/>
                </a:ext>
              </a:extLst>
            </p:cNvPr>
            <p:cNvCxnSpPr/>
            <p:nvPr/>
          </p:nvCxnSpPr>
          <p:spPr>
            <a:xfrm>
              <a:off x="3504501" y="3277313"/>
              <a:ext cx="0" cy="36045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EE09483-B85B-4448-910D-F672CA00C071}"/>
                </a:ext>
              </a:extLst>
            </p:cNvPr>
            <p:cNvSpPr txBox="1"/>
            <p:nvPr/>
          </p:nvSpPr>
          <p:spPr>
            <a:xfrm>
              <a:off x="1068797" y="3022412"/>
              <a:ext cx="16421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wnregulation 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A4E7974-A780-4D19-A453-060ABC479A47}"/>
                </a:ext>
              </a:extLst>
            </p:cNvPr>
            <p:cNvSpPr txBox="1"/>
            <p:nvPr/>
          </p:nvSpPr>
          <p:spPr>
            <a:xfrm>
              <a:off x="2692867" y="2991504"/>
              <a:ext cx="1642145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r>
                <a:rPr lang="en-IN" sz="10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s O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F803979-675E-40B7-916F-68794BA332C3}"/>
                </a:ext>
              </a:extLst>
            </p:cNvPr>
            <p:cNvSpPr txBox="1"/>
            <p:nvPr/>
          </p:nvSpPr>
          <p:spPr>
            <a:xfrm>
              <a:off x="4502286" y="3024188"/>
              <a:ext cx="16421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regulation 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E6F1883-A685-454F-A6A6-4A47B385D9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67490" y="3492751"/>
              <a:ext cx="2574331" cy="97284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95D39E4-DAF3-4132-97D0-B80D1396B4F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5505" y="5138786"/>
              <a:ext cx="3277995" cy="101066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3558728-9E42-4B12-B117-39A32ABF653B}"/>
                </a:ext>
              </a:extLst>
            </p:cNvPr>
            <p:cNvSpPr txBox="1"/>
            <p:nvPr/>
          </p:nvSpPr>
          <p:spPr>
            <a:xfrm>
              <a:off x="1082715" y="334169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pathway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9AA5960-1409-43CF-B134-F0DB0CBF4F1E}"/>
                </a:ext>
              </a:extLst>
            </p:cNvPr>
            <p:cNvSpPr txBox="1"/>
            <p:nvPr/>
          </p:nvSpPr>
          <p:spPr>
            <a:xfrm>
              <a:off x="1082715" y="501155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ome</a:t>
              </a:r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athways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00A962C7-EBEE-4657-8254-808CB60A3D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60165" y="3461430"/>
              <a:ext cx="2726384" cy="1004162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138CCD34-395C-4EFE-80A4-0EF0122539C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67182" y="5184681"/>
              <a:ext cx="2953935" cy="1004162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71AB776-BD28-4F33-A368-421A31679ED2}"/>
                </a:ext>
              </a:extLst>
            </p:cNvPr>
            <p:cNvSpPr txBox="1"/>
            <p:nvPr/>
          </p:nvSpPr>
          <p:spPr>
            <a:xfrm>
              <a:off x="4497567" y="501155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ome</a:t>
              </a:r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athways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DC876CB-8F2C-40FF-B548-8B6086625013}"/>
                </a:ext>
              </a:extLst>
            </p:cNvPr>
            <p:cNvSpPr txBox="1"/>
            <p:nvPr/>
          </p:nvSpPr>
          <p:spPr>
            <a:xfrm>
              <a:off x="4497566" y="334169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pathways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220C4EDC-E3AE-4DB9-9600-644D9626C999}"/>
              </a:ext>
            </a:extLst>
          </p:cNvPr>
          <p:cNvGrpSpPr/>
          <p:nvPr/>
        </p:nvGrpSpPr>
        <p:grpSpPr>
          <a:xfrm>
            <a:off x="483191" y="5001097"/>
            <a:ext cx="6361201" cy="3890309"/>
            <a:chOff x="492080" y="2991504"/>
            <a:chExt cx="6361201" cy="3890309"/>
          </a:xfrm>
        </p:grpSpPr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86775E1C-D439-4BD2-AB11-46B537CB15E1}"/>
                </a:ext>
              </a:extLst>
            </p:cNvPr>
            <p:cNvCxnSpPr/>
            <p:nvPr/>
          </p:nvCxnSpPr>
          <p:spPr>
            <a:xfrm>
              <a:off x="3504501" y="3277313"/>
              <a:ext cx="0" cy="36045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154FA8E-F28C-4F46-A7DB-F7A082B9357E}"/>
                </a:ext>
              </a:extLst>
            </p:cNvPr>
            <p:cNvSpPr txBox="1"/>
            <p:nvPr/>
          </p:nvSpPr>
          <p:spPr>
            <a:xfrm>
              <a:off x="1068797" y="3022412"/>
              <a:ext cx="16421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wnregulation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9D1AADD-3F53-41A2-85F1-FD43A8F31C27}"/>
                </a:ext>
              </a:extLst>
            </p:cNvPr>
            <p:cNvSpPr txBox="1"/>
            <p:nvPr/>
          </p:nvSpPr>
          <p:spPr>
            <a:xfrm>
              <a:off x="2692867" y="2991504"/>
              <a:ext cx="1642145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r>
                <a:rPr lang="en-IN" sz="10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s KO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FB07A0-16A0-4A5A-9F81-96EA7EBE7139}"/>
                </a:ext>
              </a:extLst>
            </p:cNvPr>
            <p:cNvSpPr txBox="1"/>
            <p:nvPr/>
          </p:nvSpPr>
          <p:spPr>
            <a:xfrm>
              <a:off x="4502286" y="3024188"/>
              <a:ext cx="16421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regulation 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D89B5E6-C480-4BA3-BF8A-D91011899725}"/>
                </a:ext>
              </a:extLst>
            </p:cNvPr>
            <p:cNvSpPr txBox="1"/>
            <p:nvPr/>
          </p:nvSpPr>
          <p:spPr>
            <a:xfrm>
              <a:off x="1082715" y="334169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pathways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D0908B8-B7E5-4DA6-BF96-0A60C2511410}"/>
                </a:ext>
              </a:extLst>
            </p:cNvPr>
            <p:cNvSpPr txBox="1"/>
            <p:nvPr/>
          </p:nvSpPr>
          <p:spPr>
            <a:xfrm>
              <a:off x="1082715" y="501155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ome</a:t>
              </a:r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athways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7DAFE98-B18B-4254-8902-6C71ADDF81E6}"/>
                </a:ext>
              </a:extLst>
            </p:cNvPr>
            <p:cNvSpPr txBox="1"/>
            <p:nvPr/>
          </p:nvSpPr>
          <p:spPr>
            <a:xfrm>
              <a:off x="4497567" y="501155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ome</a:t>
              </a:r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athway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9DFB8BF-2F90-4F10-A8CD-157B13CD9AC0}"/>
                </a:ext>
              </a:extLst>
            </p:cNvPr>
            <p:cNvSpPr txBox="1"/>
            <p:nvPr/>
          </p:nvSpPr>
          <p:spPr>
            <a:xfrm>
              <a:off x="4497566" y="3341696"/>
              <a:ext cx="1642145" cy="2135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788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pathways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8BE7DF0B-6DC4-4076-AACF-FC65CABE0BB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69511" y="3566391"/>
              <a:ext cx="2907693" cy="92161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02652B24-9E36-47F3-B90D-6DE6390D0B9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02854" y="5388983"/>
              <a:ext cx="3050427" cy="959111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AE9761E-84CD-474A-9B6B-308630903D5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36106" y="3527354"/>
              <a:ext cx="2707526" cy="960646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69302DA5-C4FB-4F30-9685-875A0351326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92080" y="5343942"/>
              <a:ext cx="2863245" cy="1049193"/>
            </a:xfrm>
            <a:prstGeom prst="rect">
              <a:avLst/>
            </a:prstGeom>
          </p:spPr>
        </p:pic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8FF27FED-7A32-4DE1-8BDE-4F4D450AAFDA}"/>
              </a:ext>
            </a:extLst>
          </p:cNvPr>
          <p:cNvSpPr txBox="1"/>
          <p:nvPr/>
        </p:nvSpPr>
        <p:spPr>
          <a:xfrm>
            <a:off x="92596" y="478137"/>
            <a:ext cx="508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A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00E181B-CBDA-42A8-8DAE-B07039C394B5}"/>
              </a:ext>
            </a:extLst>
          </p:cNvPr>
          <p:cNvSpPr txBox="1"/>
          <p:nvPr/>
        </p:nvSpPr>
        <p:spPr>
          <a:xfrm>
            <a:off x="127712" y="5177885"/>
            <a:ext cx="508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B.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4363472-2816-489D-86D1-9FA2112A6644}"/>
              </a:ext>
            </a:extLst>
          </p:cNvPr>
          <p:cNvSpPr/>
          <p:nvPr/>
        </p:nvSpPr>
        <p:spPr>
          <a:xfrm>
            <a:off x="276527" y="92957"/>
            <a:ext cx="10605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/>
              <a:t>Figure.S4</a:t>
            </a:r>
          </a:p>
        </p:txBody>
      </p:sp>
    </p:spTree>
    <p:extLst>
      <p:ext uri="{BB962C8B-B14F-4D97-AF65-F5344CB8AC3E}">
        <p14:creationId xmlns:p14="http://schemas.microsoft.com/office/powerpoint/2010/main" val="27161757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171830" y="1137983"/>
            <a:ext cx="3042920" cy="3350895"/>
            <a:chOff x="171830" y="1137983"/>
            <a:chExt cx="3042920" cy="3350895"/>
          </a:xfrm>
        </p:grpSpPr>
        <p:pic>
          <p:nvPicPr>
            <p:cNvPr id="3" name="object 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36247" y="1193333"/>
              <a:ext cx="2895535" cy="3235364"/>
            </a:xfrm>
            <a:prstGeom prst="rect">
              <a:avLst/>
            </a:prstGeom>
          </p:spPr>
        </p:pic>
        <p:sp>
          <p:nvSpPr>
            <p:cNvPr id="4" name="object 4"/>
            <p:cNvSpPr/>
            <p:nvPr/>
          </p:nvSpPr>
          <p:spPr>
            <a:xfrm>
              <a:off x="176593" y="1142746"/>
              <a:ext cx="3033395" cy="3341370"/>
            </a:xfrm>
            <a:custGeom>
              <a:avLst/>
              <a:gdLst/>
              <a:ahLst/>
              <a:cxnLst/>
              <a:rect l="l" t="t" r="r" b="b"/>
              <a:pathLst>
                <a:path w="3033395" h="3341370">
                  <a:moveTo>
                    <a:pt x="0" y="3340989"/>
                  </a:moveTo>
                  <a:lnTo>
                    <a:pt x="3033141" y="3340989"/>
                  </a:lnTo>
                  <a:lnTo>
                    <a:pt x="3033141" y="0"/>
                  </a:lnTo>
                  <a:lnTo>
                    <a:pt x="0" y="0"/>
                  </a:lnTo>
                  <a:lnTo>
                    <a:pt x="0" y="3340989"/>
                  </a:lnTo>
                  <a:close/>
                </a:path>
              </a:pathLst>
            </a:custGeom>
            <a:ln w="952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" name="object 5"/>
          <p:cNvSpPr txBox="1"/>
          <p:nvPr/>
        </p:nvSpPr>
        <p:spPr>
          <a:xfrm>
            <a:off x="6095" y="556082"/>
            <a:ext cx="3171825" cy="539115"/>
          </a:xfrm>
          <a:prstGeom prst="rect">
            <a:avLst/>
          </a:prstGeom>
        </p:spPr>
        <p:txBody>
          <a:bodyPr vert="horz" wrap="square" lIns="0" tIns="46355" rIns="0" bIns="0" rtlCol="0">
            <a:spAutoFit/>
          </a:bodyPr>
          <a:lstStyle/>
          <a:p>
            <a:pPr marL="774065" marR="30480" indent="-736600">
              <a:lnSpc>
                <a:spcPts val="1920"/>
              </a:lnSpc>
              <a:spcBef>
                <a:spcPts val="365"/>
              </a:spcBef>
            </a:pPr>
            <a:r>
              <a:rPr sz="2700" spc="7" baseline="29320" dirty="0">
                <a:latin typeface="Calibri"/>
                <a:cs typeface="Calibri"/>
              </a:rPr>
              <a:t>A.</a:t>
            </a:r>
            <a:r>
              <a:rPr sz="1600" spc="5" dirty="0">
                <a:latin typeface="Times New Roman"/>
                <a:cs typeface="Times New Roman"/>
              </a:rPr>
              <a:t>Network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of</a:t>
            </a:r>
            <a:r>
              <a:rPr sz="1600" spc="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downregulated</a:t>
            </a:r>
            <a:r>
              <a:rPr sz="1600" spc="1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proteins </a:t>
            </a:r>
            <a:r>
              <a:rPr sz="1600" spc="-38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(Confidence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level</a:t>
            </a:r>
            <a:r>
              <a:rPr sz="1600" spc="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0.4)</a:t>
            </a:r>
            <a:endParaRPr sz="1600">
              <a:latin typeface="Times New Roman"/>
              <a:cs typeface="Times New Roman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2965830" y="203072"/>
            <a:ext cx="92773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Times New Roman"/>
                <a:cs typeface="Times New Roman"/>
              </a:rPr>
              <a:t>Wt</a:t>
            </a:r>
            <a:r>
              <a:rPr sz="1800" spc="-30" dirty="0">
                <a:latin typeface="Times New Roman"/>
                <a:cs typeface="Times New Roman"/>
              </a:rPr>
              <a:t> </a:t>
            </a:r>
            <a:r>
              <a:rPr sz="1800" spc="-5" dirty="0">
                <a:latin typeface="Times New Roman"/>
                <a:cs typeface="Times New Roman"/>
              </a:rPr>
              <a:t>vs</a:t>
            </a:r>
            <a:r>
              <a:rPr sz="1800" spc="-35" dirty="0">
                <a:latin typeface="Times New Roman"/>
                <a:cs typeface="Times New Roman"/>
              </a:rPr>
              <a:t> </a:t>
            </a:r>
            <a:r>
              <a:rPr sz="1800" spc="-5" dirty="0">
                <a:latin typeface="Times New Roman"/>
                <a:cs typeface="Times New Roman"/>
              </a:rPr>
              <a:t>OE</a:t>
            </a:r>
            <a:endParaRPr sz="1800">
              <a:latin typeface="Times New Roman"/>
              <a:cs typeface="Times New Roman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3721989" y="590550"/>
            <a:ext cx="2723515" cy="51308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448945" marR="5080" indent="-436245">
              <a:lnSpc>
                <a:spcPct val="100000"/>
              </a:lnSpc>
              <a:spcBef>
                <a:spcPts val="95"/>
              </a:spcBef>
            </a:pPr>
            <a:r>
              <a:rPr sz="1600" spc="-5" dirty="0">
                <a:latin typeface="Times New Roman"/>
                <a:cs typeface="Times New Roman"/>
              </a:rPr>
              <a:t>Network</a:t>
            </a:r>
            <a:r>
              <a:rPr sz="1600" spc="10" dirty="0">
                <a:latin typeface="Times New Roman"/>
                <a:cs typeface="Times New Roman"/>
              </a:rPr>
              <a:t> </a:t>
            </a:r>
            <a:r>
              <a:rPr sz="1600" dirty="0">
                <a:latin typeface="Times New Roman"/>
                <a:cs typeface="Times New Roman"/>
              </a:rPr>
              <a:t>of</a:t>
            </a:r>
            <a:r>
              <a:rPr sz="1600" spc="1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Upregulated</a:t>
            </a:r>
            <a:r>
              <a:rPr sz="1600" spc="2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proteins </a:t>
            </a:r>
            <a:r>
              <a:rPr sz="1600" spc="-38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(Confidence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level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0.4)</a:t>
            </a:r>
            <a:endParaRPr sz="1600">
              <a:latin typeface="Times New Roman"/>
              <a:cs typeface="Times New Roman"/>
            </a:endParaRPr>
          </a:p>
        </p:txBody>
      </p:sp>
      <p:grpSp>
        <p:nvGrpSpPr>
          <p:cNvPr id="8" name="object 8"/>
          <p:cNvGrpSpPr/>
          <p:nvPr/>
        </p:nvGrpSpPr>
        <p:grpSpPr>
          <a:xfrm>
            <a:off x="3419411" y="1137983"/>
            <a:ext cx="3267075" cy="3350895"/>
            <a:chOff x="3419411" y="1137983"/>
            <a:chExt cx="3267075" cy="3350895"/>
          </a:xfrm>
        </p:grpSpPr>
        <p:pic>
          <p:nvPicPr>
            <p:cNvPr id="9" name="object 9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470167" y="1188757"/>
              <a:ext cx="3206476" cy="3244516"/>
            </a:xfrm>
            <a:prstGeom prst="rect">
              <a:avLst/>
            </a:prstGeom>
          </p:spPr>
        </p:pic>
        <p:sp>
          <p:nvSpPr>
            <p:cNvPr id="10" name="object 10"/>
            <p:cNvSpPr/>
            <p:nvPr/>
          </p:nvSpPr>
          <p:spPr>
            <a:xfrm>
              <a:off x="3424173" y="1142746"/>
              <a:ext cx="3257550" cy="3341370"/>
            </a:xfrm>
            <a:custGeom>
              <a:avLst/>
              <a:gdLst/>
              <a:ahLst/>
              <a:cxnLst/>
              <a:rect l="l" t="t" r="r" b="b"/>
              <a:pathLst>
                <a:path w="3257550" h="3341370">
                  <a:moveTo>
                    <a:pt x="0" y="3340989"/>
                  </a:moveTo>
                  <a:lnTo>
                    <a:pt x="3257169" y="3340989"/>
                  </a:lnTo>
                  <a:lnTo>
                    <a:pt x="3257169" y="0"/>
                  </a:lnTo>
                  <a:lnTo>
                    <a:pt x="0" y="0"/>
                  </a:lnTo>
                  <a:lnTo>
                    <a:pt x="0" y="3340989"/>
                  </a:lnTo>
                  <a:close/>
                </a:path>
              </a:pathLst>
            </a:custGeom>
            <a:ln w="952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" name="object 11"/>
          <p:cNvSpPr txBox="1"/>
          <p:nvPr/>
        </p:nvSpPr>
        <p:spPr>
          <a:xfrm>
            <a:off x="3064255" y="4728235"/>
            <a:ext cx="3522345" cy="946785"/>
          </a:xfrm>
          <a:prstGeom prst="rect">
            <a:avLst/>
          </a:prstGeom>
        </p:spPr>
        <p:txBody>
          <a:bodyPr vert="horz" wrap="square" lIns="0" tIns="10731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844"/>
              </a:spcBef>
            </a:pPr>
            <a:r>
              <a:rPr sz="1600" spc="-10" dirty="0">
                <a:latin typeface="Times New Roman"/>
                <a:cs typeface="Times New Roman"/>
              </a:rPr>
              <a:t>Wt </a:t>
            </a:r>
            <a:r>
              <a:rPr sz="1600" dirty="0">
                <a:latin typeface="Times New Roman"/>
                <a:cs typeface="Times New Roman"/>
              </a:rPr>
              <a:t>vs</a:t>
            </a:r>
            <a:r>
              <a:rPr sz="1600" spc="-2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KO</a:t>
            </a:r>
            <a:endParaRPr sz="1600">
              <a:latin typeface="Times New Roman"/>
              <a:cs typeface="Times New Roman"/>
            </a:endParaRPr>
          </a:p>
          <a:p>
            <a:pPr marL="1250315" marR="5080" indent="-434975">
              <a:lnSpc>
                <a:spcPct val="100000"/>
              </a:lnSpc>
              <a:spcBef>
                <a:spcPts val="745"/>
              </a:spcBef>
            </a:pPr>
            <a:r>
              <a:rPr sz="1600" spc="-5" dirty="0">
                <a:latin typeface="Times New Roman"/>
                <a:cs typeface="Times New Roman"/>
              </a:rPr>
              <a:t>Network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of</a:t>
            </a:r>
            <a:r>
              <a:rPr sz="1600" spc="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Upregulated</a:t>
            </a:r>
            <a:r>
              <a:rPr sz="1600" spc="2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proteins </a:t>
            </a:r>
            <a:r>
              <a:rPr sz="1600" spc="-38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(Confidence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level</a:t>
            </a:r>
            <a:r>
              <a:rPr sz="1600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0.4)</a:t>
            </a:r>
            <a:endParaRPr sz="1600">
              <a:latin typeface="Times New Roman"/>
              <a:cs typeface="Times New Roman"/>
            </a:endParaRPr>
          </a:p>
        </p:txBody>
      </p:sp>
      <p:grpSp>
        <p:nvGrpSpPr>
          <p:cNvPr id="12" name="object 12"/>
          <p:cNvGrpSpPr/>
          <p:nvPr/>
        </p:nvGrpSpPr>
        <p:grpSpPr>
          <a:xfrm>
            <a:off x="171830" y="5895975"/>
            <a:ext cx="3042920" cy="3455670"/>
            <a:chOff x="171830" y="5895975"/>
            <a:chExt cx="3042920" cy="3455670"/>
          </a:xfrm>
        </p:grpSpPr>
        <p:pic>
          <p:nvPicPr>
            <p:cNvPr id="13" name="object 13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22524" y="5937532"/>
              <a:ext cx="2982447" cy="3363403"/>
            </a:xfrm>
            <a:prstGeom prst="rect">
              <a:avLst/>
            </a:prstGeom>
          </p:spPr>
        </p:pic>
        <p:sp>
          <p:nvSpPr>
            <p:cNvPr id="14" name="object 14"/>
            <p:cNvSpPr/>
            <p:nvPr/>
          </p:nvSpPr>
          <p:spPr>
            <a:xfrm>
              <a:off x="176593" y="5900737"/>
              <a:ext cx="3033395" cy="3446145"/>
            </a:xfrm>
            <a:custGeom>
              <a:avLst/>
              <a:gdLst/>
              <a:ahLst/>
              <a:cxnLst/>
              <a:rect l="l" t="t" r="r" b="b"/>
              <a:pathLst>
                <a:path w="3033395" h="3446145">
                  <a:moveTo>
                    <a:pt x="0" y="3446145"/>
                  </a:moveTo>
                  <a:lnTo>
                    <a:pt x="3033141" y="3446145"/>
                  </a:lnTo>
                  <a:lnTo>
                    <a:pt x="3033141" y="0"/>
                  </a:lnTo>
                  <a:lnTo>
                    <a:pt x="0" y="0"/>
                  </a:lnTo>
                  <a:lnTo>
                    <a:pt x="0" y="3446145"/>
                  </a:lnTo>
                  <a:close/>
                </a:path>
              </a:pathLst>
            </a:custGeom>
            <a:ln w="952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" name="object 15"/>
          <p:cNvSpPr txBox="1"/>
          <p:nvPr/>
        </p:nvSpPr>
        <p:spPr>
          <a:xfrm>
            <a:off x="597814" y="4986273"/>
            <a:ext cx="2214880" cy="75692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95"/>
              </a:spcBef>
            </a:pPr>
            <a:r>
              <a:rPr sz="1600" spc="-5" dirty="0">
                <a:latin typeface="Times New Roman"/>
                <a:cs typeface="Times New Roman"/>
              </a:rPr>
              <a:t>Network of downregulated </a:t>
            </a:r>
            <a:r>
              <a:rPr sz="1600" spc="-385" dirty="0">
                <a:latin typeface="Times New Roman"/>
                <a:cs typeface="Times New Roman"/>
              </a:rPr>
              <a:t> </a:t>
            </a:r>
            <a:r>
              <a:rPr sz="1600" spc="-5" dirty="0">
                <a:latin typeface="Times New Roman"/>
                <a:cs typeface="Times New Roman"/>
              </a:rPr>
              <a:t>proteins</a:t>
            </a:r>
            <a:endParaRPr sz="1600">
              <a:latin typeface="Times New Roman"/>
              <a:cs typeface="Times New Roman"/>
            </a:endParaRPr>
          </a:p>
          <a:p>
            <a:pPr algn="ctr">
              <a:lnSpc>
                <a:spcPct val="100000"/>
              </a:lnSpc>
            </a:pPr>
            <a:r>
              <a:rPr sz="1600" spc="-5" dirty="0">
                <a:latin typeface="Times New Roman"/>
                <a:cs typeface="Times New Roman"/>
              </a:rPr>
              <a:t>(Confidence level 0.4)</a:t>
            </a:r>
            <a:endParaRPr sz="1600">
              <a:latin typeface="Times New Roman"/>
              <a:cs typeface="Times New Roman"/>
            </a:endParaRPr>
          </a:p>
        </p:txBody>
      </p:sp>
      <p:grpSp>
        <p:nvGrpSpPr>
          <p:cNvPr id="16" name="object 16"/>
          <p:cNvGrpSpPr/>
          <p:nvPr/>
        </p:nvGrpSpPr>
        <p:grpSpPr>
          <a:xfrm>
            <a:off x="3478847" y="5903595"/>
            <a:ext cx="3267075" cy="3457575"/>
            <a:chOff x="3478847" y="5903595"/>
            <a:chExt cx="3267075" cy="3457575"/>
          </a:xfrm>
        </p:grpSpPr>
        <p:pic>
          <p:nvPicPr>
            <p:cNvPr id="17" name="object 17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754909" y="5968057"/>
              <a:ext cx="2551482" cy="3309957"/>
            </a:xfrm>
            <a:prstGeom prst="rect">
              <a:avLst/>
            </a:prstGeom>
          </p:spPr>
        </p:pic>
        <p:sp>
          <p:nvSpPr>
            <p:cNvPr id="18" name="object 18"/>
            <p:cNvSpPr/>
            <p:nvPr/>
          </p:nvSpPr>
          <p:spPr>
            <a:xfrm>
              <a:off x="3483609" y="5908357"/>
              <a:ext cx="3257550" cy="3448050"/>
            </a:xfrm>
            <a:custGeom>
              <a:avLst/>
              <a:gdLst/>
              <a:ahLst/>
              <a:cxnLst/>
              <a:rect l="l" t="t" r="r" b="b"/>
              <a:pathLst>
                <a:path w="3257550" h="3448050">
                  <a:moveTo>
                    <a:pt x="0" y="3447669"/>
                  </a:moveTo>
                  <a:lnTo>
                    <a:pt x="3257168" y="3447669"/>
                  </a:lnTo>
                  <a:lnTo>
                    <a:pt x="3257168" y="0"/>
                  </a:lnTo>
                  <a:lnTo>
                    <a:pt x="0" y="0"/>
                  </a:lnTo>
                  <a:lnTo>
                    <a:pt x="0" y="3447669"/>
                  </a:lnTo>
                  <a:close/>
                </a:path>
              </a:pathLst>
            </a:custGeom>
            <a:ln w="952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" name="object 19"/>
          <p:cNvSpPr txBox="1"/>
          <p:nvPr/>
        </p:nvSpPr>
        <p:spPr>
          <a:xfrm>
            <a:off x="173228" y="148590"/>
            <a:ext cx="94678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Figure.</a:t>
            </a:r>
            <a:r>
              <a:rPr sz="1800" b="1" spc="-9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S5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173228" y="4950333"/>
            <a:ext cx="20891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B.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421891" y="816863"/>
            <a:ext cx="4538471" cy="4264152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5187822" y="9396780"/>
            <a:ext cx="1508760" cy="3302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95"/>
              </a:spcBef>
            </a:pPr>
            <a:r>
              <a:rPr sz="1000" spc="-5" dirty="0">
                <a:latin typeface="Calibri"/>
                <a:cs typeface="Calibri"/>
              </a:rPr>
              <a:t>Physical</a:t>
            </a:r>
            <a:r>
              <a:rPr sz="1000" spc="-45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interactions=</a:t>
            </a:r>
            <a:r>
              <a:rPr sz="1000" spc="-15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Yellow </a:t>
            </a:r>
            <a:r>
              <a:rPr sz="1000" spc="-210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Genetic</a:t>
            </a:r>
            <a:r>
              <a:rPr sz="1000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interactions=red</a:t>
            </a:r>
            <a:endParaRPr sz="10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917698" y="212598"/>
            <a:ext cx="1315085" cy="3302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95"/>
              </a:spcBef>
            </a:pPr>
            <a:r>
              <a:rPr sz="1000" b="1" spc="-5" dirty="0">
                <a:latin typeface="Calibri"/>
                <a:cs typeface="Calibri"/>
              </a:rPr>
              <a:t>I. Interactions</a:t>
            </a:r>
            <a:r>
              <a:rPr sz="1000" b="1" dirty="0">
                <a:latin typeface="Calibri"/>
                <a:cs typeface="Calibri"/>
              </a:rPr>
              <a:t> </a:t>
            </a:r>
            <a:r>
              <a:rPr sz="1000" b="1" spc="-5" dirty="0">
                <a:latin typeface="Calibri"/>
                <a:cs typeface="Calibri"/>
              </a:rPr>
              <a:t>with </a:t>
            </a:r>
            <a:r>
              <a:rPr sz="1000" b="1" spc="-10" dirty="0">
                <a:latin typeface="Calibri"/>
                <a:cs typeface="Calibri"/>
              </a:rPr>
              <a:t>High </a:t>
            </a:r>
            <a:r>
              <a:rPr sz="1000" b="1" spc="-215" dirty="0">
                <a:latin typeface="Calibri"/>
                <a:cs typeface="Calibri"/>
              </a:rPr>
              <a:t> </a:t>
            </a:r>
            <a:r>
              <a:rPr sz="1000" b="1" spc="-5" dirty="0">
                <a:latin typeface="Calibri"/>
                <a:cs typeface="Calibri"/>
              </a:rPr>
              <a:t>throughput</a:t>
            </a:r>
            <a:r>
              <a:rPr sz="1000" b="1" spc="-20" dirty="0">
                <a:latin typeface="Calibri"/>
                <a:cs typeface="Calibri"/>
              </a:rPr>
              <a:t> </a:t>
            </a:r>
            <a:r>
              <a:rPr sz="1000" b="1" spc="-5" dirty="0">
                <a:latin typeface="Calibri"/>
                <a:cs typeface="Calibri"/>
              </a:rPr>
              <a:t>screening</a:t>
            </a:r>
            <a:endParaRPr sz="1000">
              <a:latin typeface="Calibri"/>
              <a:cs typeface="Calibri"/>
            </a:endParaRPr>
          </a:p>
        </p:txBody>
      </p:sp>
      <p:pic>
        <p:nvPicPr>
          <p:cNvPr id="5" name="object 5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749551" y="5654040"/>
            <a:ext cx="3651504" cy="3916679"/>
          </a:xfrm>
          <a:prstGeom prst="rect">
            <a:avLst/>
          </a:prstGeom>
        </p:spPr>
      </p:pic>
      <p:sp>
        <p:nvSpPr>
          <p:cNvPr id="6" name="object 6"/>
          <p:cNvSpPr txBox="1"/>
          <p:nvPr/>
        </p:nvSpPr>
        <p:spPr>
          <a:xfrm>
            <a:off x="2830195" y="5250307"/>
            <a:ext cx="1490980" cy="3302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89230" marR="5080" indent="-177165">
              <a:lnSpc>
                <a:spcPct val="100000"/>
              </a:lnSpc>
              <a:spcBef>
                <a:spcPts val="95"/>
              </a:spcBef>
            </a:pPr>
            <a:r>
              <a:rPr sz="1000" spc="-5" dirty="0">
                <a:latin typeface="Calibri"/>
                <a:cs typeface="Calibri"/>
              </a:rPr>
              <a:t>II. Interactions</a:t>
            </a:r>
            <a:r>
              <a:rPr sz="1000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without High </a:t>
            </a:r>
            <a:r>
              <a:rPr sz="1000" spc="-215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throughput</a:t>
            </a:r>
            <a:r>
              <a:rPr sz="1000" spc="-20" dirty="0">
                <a:latin typeface="Calibri"/>
                <a:cs typeface="Calibri"/>
              </a:rPr>
              <a:t> </a:t>
            </a:r>
            <a:r>
              <a:rPr sz="1000" spc="-5" dirty="0">
                <a:latin typeface="Calibri"/>
                <a:cs typeface="Calibri"/>
              </a:rPr>
              <a:t>screening</a:t>
            </a:r>
            <a:endParaRPr sz="10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180543" y="190881"/>
            <a:ext cx="94678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Figure.</a:t>
            </a:r>
            <a:r>
              <a:rPr sz="1800" b="1" spc="-9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S6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483108" y="1810511"/>
            <a:ext cx="1437132" cy="1368552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2026920" y="1810511"/>
            <a:ext cx="1435608" cy="1368552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3575303" y="1810511"/>
            <a:ext cx="1434084" cy="1368552"/>
          </a:xfrm>
          <a:prstGeom prst="rect">
            <a:avLst/>
          </a:prstGeom>
        </p:spPr>
      </p:pic>
      <p:pic>
        <p:nvPicPr>
          <p:cNvPr id="5" name="object 5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2026920" y="3302508"/>
            <a:ext cx="1435608" cy="1370076"/>
          </a:xfrm>
          <a:prstGeom prst="rect">
            <a:avLst/>
          </a:prstGeom>
        </p:spPr>
      </p:pic>
      <p:pic>
        <p:nvPicPr>
          <p:cNvPr id="6" name="object 6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475487" y="3304032"/>
            <a:ext cx="1435608" cy="1368552"/>
          </a:xfrm>
          <a:prstGeom prst="rect">
            <a:avLst/>
          </a:prstGeom>
        </p:spPr>
      </p:pic>
      <p:pic>
        <p:nvPicPr>
          <p:cNvPr id="7" name="object 7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3578352" y="3302508"/>
            <a:ext cx="1434084" cy="1370076"/>
          </a:xfrm>
          <a:prstGeom prst="rect">
            <a:avLst/>
          </a:prstGeom>
        </p:spPr>
      </p:pic>
      <p:sp>
        <p:nvSpPr>
          <p:cNvPr id="8" name="object 8"/>
          <p:cNvSpPr txBox="1"/>
          <p:nvPr/>
        </p:nvSpPr>
        <p:spPr>
          <a:xfrm>
            <a:off x="252171" y="2029753"/>
            <a:ext cx="177800" cy="9309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240"/>
              </a:lnSpc>
            </a:pPr>
            <a:r>
              <a:rPr sz="1200" b="1" dirty="0">
                <a:latin typeface="Calibri"/>
                <a:cs typeface="Calibri"/>
              </a:rPr>
              <a:t>Si</a:t>
            </a:r>
            <a:r>
              <a:rPr sz="1200" b="1" spc="-65" dirty="0">
                <a:latin typeface="Calibri"/>
                <a:cs typeface="Calibri"/>
              </a:rPr>
              <a:t> </a:t>
            </a:r>
            <a:r>
              <a:rPr sz="1200" b="1" spc="-5" dirty="0">
                <a:latin typeface="Calibri"/>
                <a:cs typeface="Calibri"/>
              </a:rPr>
              <a:t>Control(HU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252171" y="3659909"/>
            <a:ext cx="177800" cy="86677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240"/>
              </a:lnSpc>
            </a:pPr>
            <a:r>
              <a:rPr sz="1200" b="1" dirty="0">
                <a:latin typeface="Calibri"/>
                <a:cs typeface="Calibri"/>
              </a:rPr>
              <a:t>Si</a:t>
            </a:r>
            <a:r>
              <a:rPr sz="1200" b="1" spc="-55" dirty="0">
                <a:latin typeface="Calibri"/>
                <a:cs typeface="Calibri"/>
              </a:rPr>
              <a:t> </a:t>
            </a:r>
            <a:r>
              <a:rPr sz="1200" b="1" spc="-5" dirty="0">
                <a:latin typeface="Calibri"/>
                <a:cs typeface="Calibri"/>
              </a:rPr>
              <a:t>USP37(HU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891032" y="1481073"/>
            <a:ext cx="33337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25" dirty="0">
                <a:latin typeface="Calibri"/>
                <a:cs typeface="Calibri"/>
              </a:rPr>
              <a:t>D</a:t>
            </a:r>
            <a:r>
              <a:rPr sz="1200" b="1" dirty="0">
                <a:latin typeface="Calibri"/>
                <a:cs typeface="Calibri"/>
              </a:rPr>
              <a:t>A</a:t>
            </a:r>
            <a:r>
              <a:rPr sz="1200" b="1" spc="-5" dirty="0">
                <a:latin typeface="Calibri"/>
                <a:cs typeface="Calibri"/>
              </a:rPr>
              <a:t>PI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457957" y="1531061"/>
            <a:ext cx="513080" cy="2089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γH2</a:t>
            </a:r>
            <a:r>
              <a:rPr sz="1200" b="1" spc="-40" dirty="0">
                <a:latin typeface="Arial"/>
                <a:cs typeface="Arial"/>
              </a:rPr>
              <a:t>A</a:t>
            </a:r>
            <a:r>
              <a:rPr sz="1200" b="1" dirty="0">
                <a:latin typeface="Arial"/>
                <a:cs typeface="Arial"/>
              </a:rPr>
              <a:t>X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4087114" y="1481073"/>
            <a:ext cx="56832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Arial"/>
                <a:cs typeface="Arial"/>
              </a:rPr>
              <a:t>Merged</a:t>
            </a:r>
            <a:endParaRPr sz="1200">
              <a:latin typeface="Arial"/>
              <a:cs typeface="Arial"/>
            </a:endParaRPr>
          </a:p>
        </p:txBody>
      </p:sp>
      <p:pic>
        <p:nvPicPr>
          <p:cNvPr id="13" name="object 13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5117591" y="2211323"/>
            <a:ext cx="1711452" cy="2461260"/>
          </a:xfrm>
          <a:prstGeom prst="rect">
            <a:avLst/>
          </a:prstGeom>
        </p:spPr>
      </p:pic>
      <p:pic>
        <p:nvPicPr>
          <p:cNvPr id="14" name="object 14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381000" y="7050023"/>
            <a:ext cx="1336548" cy="1290828"/>
          </a:xfrm>
          <a:prstGeom prst="rect">
            <a:avLst/>
          </a:prstGeom>
        </p:spPr>
      </p:pic>
      <p:pic>
        <p:nvPicPr>
          <p:cNvPr id="15" name="object 15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1958339" y="7050023"/>
            <a:ext cx="1367027" cy="1290828"/>
          </a:xfrm>
          <a:prstGeom prst="rect">
            <a:avLst/>
          </a:prstGeom>
        </p:spPr>
      </p:pic>
      <p:pic>
        <p:nvPicPr>
          <p:cNvPr id="16" name="object 16"/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3625596" y="7050023"/>
            <a:ext cx="1383791" cy="1290828"/>
          </a:xfrm>
          <a:prstGeom prst="rect">
            <a:avLst/>
          </a:prstGeom>
        </p:spPr>
      </p:pic>
      <p:sp>
        <p:nvSpPr>
          <p:cNvPr id="17" name="object 17"/>
          <p:cNvSpPr txBox="1"/>
          <p:nvPr/>
        </p:nvSpPr>
        <p:spPr>
          <a:xfrm>
            <a:off x="162559" y="7263788"/>
            <a:ext cx="177800" cy="86677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240"/>
              </a:lnSpc>
            </a:pPr>
            <a:r>
              <a:rPr sz="1200" b="1" dirty="0">
                <a:latin typeface="Calibri"/>
                <a:cs typeface="Calibri"/>
              </a:rPr>
              <a:t>Si</a:t>
            </a:r>
            <a:r>
              <a:rPr sz="1200" b="1" spc="-55" dirty="0">
                <a:latin typeface="Calibri"/>
                <a:cs typeface="Calibri"/>
              </a:rPr>
              <a:t> </a:t>
            </a:r>
            <a:r>
              <a:rPr sz="1200" b="1" spc="-5" dirty="0">
                <a:latin typeface="Calibri"/>
                <a:cs typeface="Calibri"/>
              </a:rPr>
              <a:t>USP37(HU)</a:t>
            </a:r>
            <a:endParaRPr sz="1200">
              <a:latin typeface="Calibri"/>
              <a:cs typeface="Calibri"/>
            </a:endParaRPr>
          </a:p>
        </p:txBody>
      </p:sp>
      <p:pic>
        <p:nvPicPr>
          <p:cNvPr id="18" name="object 18"/>
          <p:cNvPicPr/>
          <p:nvPr/>
        </p:nvPicPr>
        <p:blipFill>
          <a:blip r:embed="rId12" cstate="print"/>
          <a:stretch>
            <a:fillRect/>
          </a:stretch>
        </p:blipFill>
        <p:spPr>
          <a:xfrm>
            <a:off x="3625596" y="5605271"/>
            <a:ext cx="1383791" cy="1339595"/>
          </a:xfrm>
          <a:prstGeom prst="rect">
            <a:avLst/>
          </a:prstGeom>
        </p:spPr>
      </p:pic>
      <p:pic>
        <p:nvPicPr>
          <p:cNvPr id="19" name="object 19"/>
          <p:cNvPicPr/>
          <p:nvPr/>
        </p:nvPicPr>
        <p:blipFill>
          <a:blip r:embed="rId13" cstate="print"/>
          <a:stretch>
            <a:fillRect/>
          </a:stretch>
        </p:blipFill>
        <p:spPr>
          <a:xfrm>
            <a:off x="381000" y="5626608"/>
            <a:ext cx="1333500" cy="1290827"/>
          </a:xfrm>
          <a:prstGeom prst="rect">
            <a:avLst/>
          </a:prstGeom>
        </p:spPr>
      </p:pic>
      <p:pic>
        <p:nvPicPr>
          <p:cNvPr id="20" name="object 20"/>
          <p:cNvPicPr/>
          <p:nvPr/>
        </p:nvPicPr>
        <p:blipFill>
          <a:blip r:embed="rId14" cstate="print"/>
          <a:stretch>
            <a:fillRect/>
          </a:stretch>
        </p:blipFill>
        <p:spPr>
          <a:xfrm>
            <a:off x="1958339" y="5626608"/>
            <a:ext cx="1367027" cy="1290827"/>
          </a:xfrm>
          <a:prstGeom prst="rect">
            <a:avLst/>
          </a:prstGeom>
        </p:spPr>
      </p:pic>
      <p:sp>
        <p:nvSpPr>
          <p:cNvPr id="21" name="object 21"/>
          <p:cNvSpPr txBox="1"/>
          <p:nvPr/>
        </p:nvSpPr>
        <p:spPr>
          <a:xfrm>
            <a:off x="162559" y="5773332"/>
            <a:ext cx="177800" cy="9309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240"/>
              </a:lnSpc>
            </a:pPr>
            <a:r>
              <a:rPr sz="1200" b="1" dirty="0">
                <a:latin typeface="Calibri"/>
                <a:cs typeface="Calibri"/>
              </a:rPr>
              <a:t>Si</a:t>
            </a:r>
            <a:r>
              <a:rPr sz="1200" b="1" spc="-45" dirty="0">
                <a:latin typeface="Calibri"/>
                <a:cs typeface="Calibri"/>
              </a:rPr>
              <a:t> </a:t>
            </a:r>
            <a:r>
              <a:rPr sz="1200" b="1" spc="-5" dirty="0">
                <a:latin typeface="Calibri"/>
                <a:cs typeface="Calibri"/>
              </a:rPr>
              <a:t>Control(HU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839520" y="5318505"/>
            <a:ext cx="384810" cy="23939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b="1" spc="-30" dirty="0">
                <a:latin typeface="Calibri"/>
                <a:cs typeface="Calibri"/>
              </a:rPr>
              <a:t>D</a:t>
            </a:r>
            <a:r>
              <a:rPr sz="1400" b="1" dirty="0">
                <a:latin typeface="Calibri"/>
                <a:cs typeface="Calibri"/>
              </a:rPr>
              <a:t>API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2299461" y="5307329"/>
            <a:ext cx="569595" cy="23939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b="1" dirty="0">
                <a:latin typeface="Arial"/>
                <a:cs typeface="Arial"/>
              </a:rPr>
              <a:t>53</a:t>
            </a:r>
            <a:r>
              <a:rPr sz="1400" b="1" spc="-10" dirty="0">
                <a:latin typeface="Arial"/>
                <a:cs typeface="Arial"/>
              </a:rPr>
              <a:t>B</a:t>
            </a:r>
            <a:r>
              <a:rPr sz="1400" b="1" dirty="0">
                <a:latin typeface="Arial"/>
                <a:cs typeface="Arial"/>
              </a:rPr>
              <a:t>P1</a:t>
            </a:r>
            <a:endParaRPr sz="1400">
              <a:latin typeface="Arial"/>
              <a:cs typeface="Arial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3975353" y="5276214"/>
            <a:ext cx="661670" cy="23939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b="1" spc="15" dirty="0">
                <a:latin typeface="Arial"/>
                <a:cs typeface="Arial"/>
              </a:rPr>
              <a:t>M</a:t>
            </a:r>
            <a:r>
              <a:rPr sz="1400" b="1" dirty="0">
                <a:latin typeface="Arial"/>
                <a:cs typeface="Arial"/>
              </a:rPr>
              <a:t>er</a:t>
            </a:r>
            <a:r>
              <a:rPr sz="1400" b="1" spc="-10" dirty="0">
                <a:latin typeface="Arial"/>
                <a:cs typeface="Arial"/>
              </a:rPr>
              <a:t>g</a:t>
            </a:r>
            <a:r>
              <a:rPr sz="1400" b="1" dirty="0">
                <a:latin typeface="Arial"/>
                <a:cs typeface="Arial"/>
              </a:rPr>
              <a:t>ed</a:t>
            </a:r>
            <a:endParaRPr sz="140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272592" y="1374775"/>
            <a:ext cx="21907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10" dirty="0">
                <a:latin typeface="Calibri"/>
                <a:cs typeface="Calibri"/>
              </a:rPr>
              <a:t>A.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143967" y="5208523"/>
            <a:ext cx="20891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B.</a:t>
            </a:r>
            <a:endParaRPr sz="1800">
              <a:latin typeface="Calibri"/>
              <a:cs typeface="Calibri"/>
            </a:endParaRPr>
          </a:p>
        </p:txBody>
      </p:sp>
      <p:pic>
        <p:nvPicPr>
          <p:cNvPr id="27" name="object 27"/>
          <p:cNvPicPr/>
          <p:nvPr/>
        </p:nvPicPr>
        <p:blipFill>
          <a:blip r:embed="rId15" cstate="print"/>
          <a:stretch>
            <a:fillRect/>
          </a:stretch>
        </p:blipFill>
        <p:spPr>
          <a:xfrm>
            <a:off x="5345576" y="5901663"/>
            <a:ext cx="1225485" cy="2417862"/>
          </a:xfrm>
          <a:prstGeom prst="rect">
            <a:avLst/>
          </a:prstGeom>
        </p:spPr>
      </p:pic>
      <p:sp>
        <p:nvSpPr>
          <p:cNvPr id="28" name="object 28"/>
          <p:cNvSpPr txBox="1"/>
          <p:nvPr/>
        </p:nvSpPr>
        <p:spPr>
          <a:xfrm>
            <a:off x="258876" y="396367"/>
            <a:ext cx="94615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Figure.</a:t>
            </a:r>
            <a:r>
              <a:rPr sz="1800" b="1" spc="-9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S7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18960" y="1994916"/>
            <a:ext cx="6301168" cy="4110228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75640" y="530479"/>
            <a:ext cx="100393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dirty="0">
                <a:latin typeface="Calibri"/>
                <a:cs typeface="Calibri"/>
              </a:rPr>
              <a:t>Fig</a:t>
            </a:r>
            <a:r>
              <a:rPr sz="1800" b="1" spc="5" dirty="0">
                <a:latin typeface="Calibri"/>
                <a:cs typeface="Calibri"/>
              </a:rPr>
              <a:t>u</a:t>
            </a:r>
            <a:r>
              <a:rPr sz="1800" b="1" spc="-30" dirty="0">
                <a:latin typeface="Calibri"/>
                <a:cs typeface="Calibri"/>
              </a:rPr>
              <a:t>r</a:t>
            </a:r>
            <a:r>
              <a:rPr sz="1800" b="1" dirty="0">
                <a:latin typeface="Calibri"/>
                <a:cs typeface="Calibri"/>
              </a:rPr>
              <a:t>e.</a:t>
            </a:r>
            <a:r>
              <a:rPr sz="1800" b="1" spc="-2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S8</a:t>
            </a:r>
            <a:r>
              <a:rPr sz="1800" dirty="0">
                <a:latin typeface="Calibri"/>
                <a:cs typeface="Calibri"/>
              </a:rPr>
              <a:t>.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75640" y="1269238"/>
            <a:ext cx="210185" cy="670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400" b="1" dirty="0">
                <a:latin typeface="Calibri"/>
                <a:cs typeface="Calibri"/>
              </a:rPr>
              <a:t>A</a:t>
            </a:r>
            <a:endParaRPr sz="24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35"/>
              </a:spcBef>
            </a:pPr>
            <a:r>
              <a:rPr sz="1800" dirty="0">
                <a:latin typeface="Calibri"/>
                <a:cs typeface="Calibri"/>
              </a:rPr>
              <a:t>.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3667505" y="1269238"/>
            <a:ext cx="196850" cy="670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400" b="1" dirty="0">
                <a:latin typeface="Calibri"/>
                <a:cs typeface="Calibri"/>
              </a:rPr>
              <a:t>B</a:t>
            </a:r>
            <a:endParaRPr sz="24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35"/>
              </a:spcBef>
            </a:pPr>
            <a:r>
              <a:rPr sz="1800" dirty="0">
                <a:latin typeface="Calibri"/>
                <a:cs typeface="Calibri"/>
              </a:rPr>
              <a:t>.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4</TotalTime>
  <Words>2327</Words>
  <Application>Microsoft Office PowerPoint</Application>
  <PresentationFormat>A4 Paper (210x297 mm)</PresentationFormat>
  <Paragraphs>1755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kshay Malhotra</dc:creator>
  <cp:lastModifiedBy>mayank singh</cp:lastModifiedBy>
  <cp:revision>2</cp:revision>
  <dcterms:created xsi:type="dcterms:W3CDTF">2023-04-04T13:40:55Z</dcterms:created>
  <dcterms:modified xsi:type="dcterms:W3CDTF">2023-04-06T10:2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03-15T00:00:00Z</vt:filetime>
  </property>
  <property fmtid="{D5CDD505-2E9C-101B-9397-08002B2CF9AE}" pid="3" name="Creator">
    <vt:lpwstr>Microsoft® PowerPoint® 2019</vt:lpwstr>
  </property>
  <property fmtid="{D5CDD505-2E9C-101B-9397-08002B2CF9AE}" pid="4" name="LastSaved">
    <vt:filetime>2023-04-04T00:00:00Z</vt:filetime>
  </property>
</Properties>
</file>